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38" autoAdjust="0"/>
    <p:restoredTop sz="94660"/>
  </p:normalViewPr>
  <p:slideViewPr>
    <p:cSldViewPr snapToGrid="0">
      <p:cViewPr varScale="1">
        <p:scale>
          <a:sx n="64" d="100"/>
          <a:sy n="64" d="100"/>
        </p:scale>
        <p:origin x="640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E1BE70-1295-4298-9F96-2818F239E70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D21640E-D3F9-4ACA-8773-062C90334B0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C2A4CA-E128-4419-A73D-A0BA8409D2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41278-C0CC-46BB-AE30-CD7EDB878037}" type="datetimeFigureOut">
              <a:rPr lang="en-US" smtClean="0"/>
              <a:t>6/2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D9022A-ED60-470F-A920-0E13599DF0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02EC3F-A5B1-4F47-9C4A-7F4C4EE53D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03FAC-FA9B-4270-86BA-DBA0FEB12A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040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D01EC1-B7DD-4C00-9312-C9842B8910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AC9B360-5605-4399-931E-CD8607FF01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159B4B-1011-418D-B207-F6CBD13264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41278-C0CC-46BB-AE30-CD7EDB878037}" type="datetimeFigureOut">
              <a:rPr lang="en-US" smtClean="0"/>
              <a:t>6/2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E15675-A46B-4204-A797-AE1F63C8B0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1D07E9-BD19-47D3-9D18-047E898198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03FAC-FA9B-4270-86BA-DBA0FEB12A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8349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4310CE1-4878-4D13-AF7A-35DC88A4ED2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EEE51B6-6518-49C2-869F-94A309DD7A3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E247FE-0E6F-43C8-A0F4-428CC4BC9D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41278-C0CC-46BB-AE30-CD7EDB878037}" type="datetimeFigureOut">
              <a:rPr lang="en-US" smtClean="0"/>
              <a:t>6/2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F2BD3C-A8CB-4931-A0B4-7D8BA2D4A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511DFC-4ED5-4725-9ADE-3F8DC35010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03FAC-FA9B-4270-86BA-DBA0FEB12A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10838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A21272-2B64-4AD4-9518-61FF1B889A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317003-DD10-4359-A180-4F86A999302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8E52D6-7C7E-4838-97BA-23CAB5339A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41278-C0CC-46BB-AE30-CD7EDB878037}" type="datetimeFigureOut">
              <a:rPr lang="en-US" smtClean="0"/>
              <a:t>6/2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F8F0C3-8729-4DAC-82D9-0F3F563042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4E9BCD-D859-4CAA-8FFE-3525DC0683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03FAC-FA9B-4270-86BA-DBA0FEB12A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89636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B32D33-EF3E-47FB-86DE-32EA739562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4CE673-E46E-4B4A-9F93-0F8DE79E74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A5AC79-42F9-4448-879C-E17BC73374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41278-C0CC-46BB-AE30-CD7EDB878037}" type="datetimeFigureOut">
              <a:rPr lang="en-US" smtClean="0"/>
              <a:t>6/2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4B5602-092B-4EB3-AAA3-2E4E5EB12C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C276D4-41B6-4456-BD9B-2C07ACAEFF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03FAC-FA9B-4270-86BA-DBA0FEB12A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6488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F26A05-7EC2-4375-8728-55573266BE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9FCA4B-01AD-4E21-BE64-2CA41DA626E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C0BBDD5-1107-48D7-8094-D7BD9DFEFF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1AB595-3572-4BF0-B6FA-4050E637D4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41278-C0CC-46BB-AE30-CD7EDB878037}" type="datetimeFigureOut">
              <a:rPr lang="en-US" smtClean="0"/>
              <a:t>6/26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7468797-D4B4-4847-8FF3-4A51C02A3F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E8AB02-6D1A-449F-8513-ADD5ADF1AC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03FAC-FA9B-4270-86BA-DBA0FEB12A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6443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A449E7-802C-4178-9D16-A16C8C4570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42D31C-DD79-463A-A551-B3572BD493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08CD7E2-2975-4E84-8AEE-51984FE7BE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04944AB-F8DA-478A-9310-73BDFB40BF8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EBE969D-8946-4D2E-88FC-30FA791B384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26552E5-8DF9-4B99-B3F1-D010D924ED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41278-C0CC-46BB-AE30-CD7EDB878037}" type="datetimeFigureOut">
              <a:rPr lang="en-US" smtClean="0"/>
              <a:t>6/26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100133C-05F0-4B7F-84A0-68438941CC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CD20F64-FE80-43CF-B8D8-A7D1C383E5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03FAC-FA9B-4270-86BA-DBA0FEB12A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85118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44A443-FB0B-4CD5-87AB-D358C4DD08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C1FA5EC-AC96-43B3-B92D-36858B62F6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41278-C0CC-46BB-AE30-CD7EDB878037}" type="datetimeFigureOut">
              <a:rPr lang="en-US" smtClean="0"/>
              <a:t>6/26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9C9747D-1559-44D7-B53A-62447B9823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FEED2B4-F49B-463D-A3C4-8DD84632BC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03FAC-FA9B-4270-86BA-DBA0FEB12A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25478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3C93BC8-CBE5-425E-92A6-92D3C5D4BE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41278-C0CC-46BB-AE30-CD7EDB878037}" type="datetimeFigureOut">
              <a:rPr lang="en-US" smtClean="0"/>
              <a:t>6/26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531DD67-34EF-4AA0-840F-E1DC8F0860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4EA2B7D-0FDB-45F9-A4E9-B90409406B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03FAC-FA9B-4270-86BA-DBA0FEB12A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8543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EAA5AA-C45F-429A-AA2A-F058DCDF0D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B52C79-3765-4619-88D7-B09519EB1B6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AC06DD5-89FD-43E6-99F5-BC07FB89FC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6F9E38-AABA-4DF0-A705-EBBC2EDBE2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41278-C0CC-46BB-AE30-CD7EDB878037}" type="datetimeFigureOut">
              <a:rPr lang="en-US" smtClean="0"/>
              <a:t>6/26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21A945-237A-4068-AFEE-E3EA15C953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60BBC00-AF37-4465-8A08-50D836A9A5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03FAC-FA9B-4270-86BA-DBA0FEB12A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12837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1F4834-22C5-4107-AA79-719A811317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98CE372-B39D-42A2-9287-775F304C321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411F8AF-B5B2-4C58-9F73-5EC0697024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956939-4CD9-4A54-98C0-FC28A0DB74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41278-C0CC-46BB-AE30-CD7EDB878037}" type="datetimeFigureOut">
              <a:rPr lang="en-US" smtClean="0"/>
              <a:t>6/26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4A7E834-6C7E-425A-8BD3-227763E8EF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DD316C-CEF3-4996-B434-5D6EF357D0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03FAC-FA9B-4270-86BA-DBA0FEB12A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29732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BA0F037-50A7-412B-AF23-3F7194C1C2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01824C6-71DA-47C1-8F46-E739F49B6F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16A802-2AE3-40E5-849E-325950EECB3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841278-C0CC-46BB-AE30-CD7EDB878037}" type="datetimeFigureOut">
              <a:rPr lang="en-US" smtClean="0"/>
              <a:t>6/2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641764-68F4-4EAD-A62D-A76E144B62E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47BD49-7456-4570-A978-8ABEABAD1BE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F03FAC-FA9B-4270-86BA-DBA0FEB12A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8695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>
            <a:extLst>
              <a:ext uri="{FF2B5EF4-FFF2-40B4-BE49-F238E27FC236}">
                <a16:creationId xmlns:a16="http://schemas.microsoft.com/office/drawing/2014/main" id="{7F4105B4-8832-4771-8BD1-F16C9F0E194F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085686685"/>
              </p:ext>
            </p:extLst>
          </p:nvPr>
        </p:nvGraphicFramePr>
        <p:xfrm>
          <a:off x="459625" y="715616"/>
          <a:ext cx="11010376" cy="5826854"/>
        </p:xfrm>
        <a:graphic>
          <a:graphicData uri="http://schemas.openxmlformats.org/drawingml/2006/table">
            <a:tbl>
              <a:tblPr/>
              <a:tblGrid>
                <a:gridCol w="846952">
                  <a:extLst>
                    <a:ext uri="{9D8B030D-6E8A-4147-A177-3AD203B41FA5}">
                      <a16:colId xmlns:a16="http://schemas.microsoft.com/office/drawing/2014/main" val="1658983923"/>
                    </a:ext>
                  </a:extLst>
                </a:gridCol>
                <a:gridCol w="846952">
                  <a:extLst>
                    <a:ext uri="{9D8B030D-6E8A-4147-A177-3AD203B41FA5}">
                      <a16:colId xmlns:a16="http://schemas.microsoft.com/office/drawing/2014/main" val="496809547"/>
                    </a:ext>
                  </a:extLst>
                </a:gridCol>
                <a:gridCol w="846952">
                  <a:extLst>
                    <a:ext uri="{9D8B030D-6E8A-4147-A177-3AD203B41FA5}">
                      <a16:colId xmlns:a16="http://schemas.microsoft.com/office/drawing/2014/main" val="4158510104"/>
                    </a:ext>
                  </a:extLst>
                </a:gridCol>
                <a:gridCol w="846952">
                  <a:extLst>
                    <a:ext uri="{9D8B030D-6E8A-4147-A177-3AD203B41FA5}">
                      <a16:colId xmlns:a16="http://schemas.microsoft.com/office/drawing/2014/main" val="4226510970"/>
                    </a:ext>
                  </a:extLst>
                </a:gridCol>
                <a:gridCol w="846952">
                  <a:extLst>
                    <a:ext uri="{9D8B030D-6E8A-4147-A177-3AD203B41FA5}">
                      <a16:colId xmlns:a16="http://schemas.microsoft.com/office/drawing/2014/main" val="3608821071"/>
                    </a:ext>
                  </a:extLst>
                </a:gridCol>
                <a:gridCol w="846952">
                  <a:extLst>
                    <a:ext uri="{9D8B030D-6E8A-4147-A177-3AD203B41FA5}">
                      <a16:colId xmlns:a16="http://schemas.microsoft.com/office/drawing/2014/main" val="2015481926"/>
                    </a:ext>
                  </a:extLst>
                </a:gridCol>
                <a:gridCol w="846952">
                  <a:extLst>
                    <a:ext uri="{9D8B030D-6E8A-4147-A177-3AD203B41FA5}">
                      <a16:colId xmlns:a16="http://schemas.microsoft.com/office/drawing/2014/main" val="1434381429"/>
                    </a:ext>
                  </a:extLst>
                </a:gridCol>
                <a:gridCol w="846952">
                  <a:extLst>
                    <a:ext uri="{9D8B030D-6E8A-4147-A177-3AD203B41FA5}">
                      <a16:colId xmlns:a16="http://schemas.microsoft.com/office/drawing/2014/main" val="2741808863"/>
                    </a:ext>
                  </a:extLst>
                </a:gridCol>
                <a:gridCol w="846952">
                  <a:extLst>
                    <a:ext uri="{9D8B030D-6E8A-4147-A177-3AD203B41FA5}">
                      <a16:colId xmlns:a16="http://schemas.microsoft.com/office/drawing/2014/main" val="2478731525"/>
                    </a:ext>
                  </a:extLst>
                </a:gridCol>
                <a:gridCol w="846952">
                  <a:extLst>
                    <a:ext uri="{9D8B030D-6E8A-4147-A177-3AD203B41FA5}">
                      <a16:colId xmlns:a16="http://schemas.microsoft.com/office/drawing/2014/main" val="2103201354"/>
                    </a:ext>
                  </a:extLst>
                </a:gridCol>
                <a:gridCol w="846952">
                  <a:extLst>
                    <a:ext uri="{9D8B030D-6E8A-4147-A177-3AD203B41FA5}">
                      <a16:colId xmlns:a16="http://schemas.microsoft.com/office/drawing/2014/main" val="2400260939"/>
                    </a:ext>
                  </a:extLst>
                </a:gridCol>
                <a:gridCol w="846952">
                  <a:extLst>
                    <a:ext uri="{9D8B030D-6E8A-4147-A177-3AD203B41FA5}">
                      <a16:colId xmlns:a16="http://schemas.microsoft.com/office/drawing/2014/main" val="856528694"/>
                    </a:ext>
                  </a:extLst>
                </a:gridCol>
                <a:gridCol w="846952">
                  <a:extLst>
                    <a:ext uri="{9D8B030D-6E8A-4147-A177-3AD203B41FA5}">
                      <a16:colId xmlns:a16="http://schemas.microsoft.com/office/drawing/2014/main" val="50004352"/>
                    </a:ext>
                  </a:extLst>
                </a:gridCol>
              </a:tblGrid>
              <a:tr h="21355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4926370"/>
                  </a:ext>
                </a:extLst>
              </a:tr>
              <a:tr h="21355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9166349"/>
                  </a:ext>
                </a:extLst>
              </a:tr>
              <a:tr h="258316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stitutional Policy Counts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8742314"/>
                  </a:ext>
                </a:extLst>
              </a:tr>
              <a:tr h="21355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18" gridSpan="6"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18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18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18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18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18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939720"/>
                  </a:ext>
                </a:extLst>
              </a:tr>
              <a:tr h="21355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6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7483176"/>
                  </a:ext>
                </a:extLst>
              </a:tr>
              <a:tr h="21355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6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6596993"/>
                  </a:ext>
                </a:extLst>
              </a:tr>
              <a:tr h="21355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6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4418670"/>
                  </a:ext>
                </a:extLst>
              </a:tr>
              <a:tr h="21355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6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30618551"/>
                  </a:ext>
                </a:extLst>
              </a:tr>
              <a:tr h="21355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6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4103804"/>
                  </a:ext>
                </a:extLst>
              </a:tr>
              <a:tr h="21355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6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3816717"/>
                  </a:ext>
                </a:extLst>
              </a:tr>
              <a:tr h="21355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6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1058870"/>
                  </a:ext>
                </a:extLst>
              </a:tr>
              <a:tr h="21355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6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5666974"/>
                  </a:ext>
                </a:extLst>
              </a:tr>
              <a:tr h="21355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6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7697860"/>
                  </a:ext>
                </a:extLst>
              </a:tr>
              <a:tr h="21355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6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29769358"/>
                  </a:ext>
                </a:extLst>
              </a:tr>
              <a:tr h="21355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6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3588935"/>
                  </a:ext>
                </a:extLst>
              </a:tr>
              <a:tr h="21355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6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3818144"/>
                  </a:ext>
                </a:extLst>
              </a:tr>
              <a:tr h="21355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6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6129108"/>
                  </a:ext>
                </a:extLst>
              </a:tr>
              <a:tr h="21355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6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2594090"/>
                  </a:ext>
                </a:extLst>
              </a:tr>
              <a:tr h="21355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6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7624113"/>
                  </a:ext>
                </a:extLst>
              </a:tr>
              <a:tr h="21355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6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1832544"/>
                  </a:ext>
                </a:extLst>
              </a:tr>
              <a:tr h="21355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6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2477927"/>
                  </a:ext>
                </a:extLst>
              </a:tr>
              <a:tr h="21355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27951995"/>
                  </a:ext>
                </a:extLst>
              </a:tr>
              <a:tr h="21355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4238477"/>
                  </a:ext>
                </a:extLst>
              </a:tr>
              <a:tr h="21355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5283878"/>
                  </a:ext>
                </a:extLst>
              </a:tr>
              <a:tr h="21355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6351742"/>
                  </a:ext>
                </a:extLst>
              </a:tr>
              <a:tr h="21355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6227552"/>
                  </a:ext>
                </a:extLst>
              </a:tr>
              <a:tr h="213559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4026634"/>
                  </a:ext>
                </a:extLst>
              </a:tr>
            </a:tbl>
          </a:graphicData>
        </a:graphic>
      </p:graphicFrame>
      <p:sp>
        <p:nvSpPr>
          <p:cNvPr id="7" name="Rounded Rectangle 1">
            <a:extLst>
              <a:ext uri="{FF2B5EF4-FFF2-40B4-BE49-F238E27FC236}">
                <a16:creationId xmlns:a16="http://schemas.microsoft.com/office/drawing/2014/main" id="{2CB97F76-9B0C-4887-951A-F4AD61EA8508}"/>
              </a:ext>
            </a:extLst>
          </p:cNvPr>
          <p:cNvSpPr/>
          <p:nvPr/>
        </p:nvSpPr>
        <p:spPr>
          <a:xfrm>
            <a:off x="1244868" y="2726501"/>
            <a:ext cx="2565979" cy="1638296"/>
          </a:xfrm>
          <a:prstGeom prst="roundRect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2000"/>
              <a:t>No</a:t>
            </a:r>
            <a:r>
              <a:rPr lang="en-US" sz="2000" baseline="0"/>
              <a:t> policy in any domain</a:t>
            </a:r>
          </a:p>
          <a:p>
            <a:pPr algn="ctr"/>
            <a:r>
              <a:rPr lang="en-US" sz="1400" baseline="0"/>
              <a:t>N=24</a:t>
            </a:r>
            <a:endParaRPr lang="en-US" sz="1400"/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5EFEF0E8-355A-43C0-B343-43546033A565}"/>
              </a:ext>
            </a:extLst>
          </p:cNvPr>
          <p:cNvCxnSpPr>
            <a:cxnSpLocks/>
          </p:cNvCxnSpPr>
          <p:nvPr/>
        </p:nvCxnSpPr>
        <p:spPr>
          <a:xfrm>
            <a:off x="4690858" y="850231"/>
            <a:ext cx="4496" cy="5640037"/>
          </a:xfrm>
          <a:prstGeom prst="line">
            <a:avLst/>
          </a:prstGeom>
          <a:ln w="38100"/>
        </p:spPr>
        <p:style>
          <a:lnRef idx="1">
            <a:schemeClr val="accent3"/>
          </a:lnRef>
          <a:fillRef idx="0">
            <a:schemeClr val="accent3"/>
          </a:fillRef>
          <a:effectRef idx="0">
            <a:schemeClr val="accent3"/>
          </a:effectRef>
          <a:fontRef idx="minor">
            <a:schemeClr val="tx1"/>
          </a:fontRef>
        </p:style>
      </p:cxnSp>
      <p:sp>
        <p:nvSpPr>
          <p:cNvPr id="9" name="Oval 8">
            <a:extLst>
              <a:ext uri="{FF2B5EF4-FFF2-40B4-BE49-F238E27FC236}">
                <a16:creationId xmlns:a16="http://schemas.microsoft.com/office/drawing/2014/main" id="{D200EF08-33BF-4F34-AB92-238A5717BC1E}"/>
              </a:ext>
            </a:extLst>
          </p:cNvPr>
          <p:cNvSpPr/>
          <p:nvPr/>
        </p:nvSpPr>
        <p:spPr>
          <a:xfrm>
            <a:off x="5964813" y="1542744"/>
            <a:ext cx="3154893" cy="2726018"/>
          </a:xfrm>
          <a:prstGeom prst="ellipse">
            <a:avLst/>
          </a:prstGeom>
          <a:solidFill>
            <a:schemeClr val="accent3">
              <a:alpha val="50000"/>
            </a:schemeClr>
          </a:solidFill>
          <a:ln>
            <a:solidFill>
              <a:schemeClr val="bg2">
                <a:lumMod val="75000"/>
              </a:schemeClr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2000" b="1" dirty="0">
                <a:solidFill>
                  <a:sysClr val="windowText" lastClr="000000"/>
                </a:solidFill>
              </a:rPr>
              <a:t>Participant</a:t>
            </a:r>
            <a:r>
              <a:rPr lang="en-US" sz="2000" b="1" baseline="0" dirty="0">
                <a:solidFill>
                  <a:sysClr val="windowText" lastClr="000000"/>
                </a:solidFill>
              </a:rPr>
              <a:t> contact</a:t>
            </a:r>
          </a:p>
          <a:p>
            <a:pPr algn="ctr"/>
            <a:r>
              <a:rPr lang="en-US" sz="1600" b="0" baseline="0" dirty="0">
                <a:solidFill>
                  <a:sysClr val="windowText" lastClr="000000"/>
                </a:solidFill>
              </a:rPr>
              <a:t>N=6</a:t>
            </a:r>
            <a:endParaRPr lang="en-US" sz="1600" b="0" dirty="0">
              <a:solidFill>
                <a:sysClr val="windowText" lastClr="000000"/>
              </a:solidFill>
            </a:endParaRPr>
          </a:p>
        </p:txBody>
      </p:sp>
      <p:sp>
        <p:nvSpPr>
          <p:cNvPr id="10" name="Oval 9">
            <a:extLst>
              <a:ext uri="{FF2B5EF4-FFF2-40B4-BE49-F238E27FC236}">
                <a16:creationId xmlns:a16="http://schemas.microsoft.com/office/drawing/2014/main" id="{01A4FB3B-16D7-4D97-9C0F-A3FE8749DC2C}"/>
              </a:ext>
            </a:extLst>
          </p:cNvPr>
          <p:cNvSpPr/>
          <p:nvPr/>
        </p:nvSpPr>
        <p:spPr>
          <a:xfrm>
            <a:off x="5084802" y="2905753"/>
            <a:ext cx="3070762" cy="2726018"/>
          </a:xfrm>
          <a:prstGeom prst="ellipse">
            <a:avLst/>
          </a:prstGeom>
          <a:solidFill>
            <a:schemeClr val="accent3">
              <a:alpha val="50000"/>
            </a:schemeClr>
          </a:solidFill>
          <a:ln>
            <a:solidFill>
              <a:schemeClr val="bg2">
                <a:lumMod val="75000"/>
              </a:schemeClr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600"/>
              <a:t> </a:t>
            </a:r>
          </a:p>
          <a:p>
            <a:pPr algn="l"/>
            <a:endParaRPr lang="en-US" sz="1600">
              <a:solidFill>
                <a:schemeClr val="lt1"/>
              </a:solidFill>
            </a:endParaRPr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78324364-19D5-4E61-9599-E751678F42E4}"/>
              </a:ext>
            </a:extLst>
          </p:cNvPr>
          <p:cNvSpPr/>
          <p:nvPr/>
        </p:nvSpPr>
        <p:spPr>
          <a:xfrm>
            <a:off x="7102720" y="2905753"/>
            <a:ext cx="2986632" cy="2726018"/>
          </a:xfrm>
          <a:prstGeom prst="ellipse">
            <a:avLst/>
          </a:prstGeom>
          <a:solidFill>
            <a:schemeClr val="accent3">
              <a:alpha val="50000"/>
            </a:schemeClr>
          </a:solidFill>
          <a:ln>
            <a:solidFill>
              <a:schemeClr val="bg2">
                <a:lumMod val="75000"/>
              </a:schemeClr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sz="1100">
              <a:solidFill>
                <a:sysClr val="windowText" lastClr="000000"/>
              </a:solidFill>
            </a:endParaRPr>
          </a:p>
        </p:txBody>
      </p:sp>
      <p:sp>
        <p:nvSpPr>
          <p:cNvPr id="12" name="TextBox 6">
            <a:extLst>
              <a:ext uri="{FF2B5EF4-FFF2-40B4-BE49-F238E27FC236}">
                <a16:creationId xmlns:a16="http://schemas.microsoft.com/office/drawing/2014/main" id="{DD214659-E266-4349-BBC2-D545405D8160}"/>
              </a:ext>
            </a:extLst>
          </p:cNvPr>
          <p:cNvSpPr txBox="1"/>
          <p:nvPr/>
        </p:nvSpPr>
        <p:spPr>
          <a:xfrm>
            <a:off x="5329397" y="4318369"/>
            <a:ext cx="1977066" cy="832577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b="1" dirty="0">
                <a:solidFill>
                  <a:schemeClr val="dk1"/>
                </a:solidFill>
                <a:effectLst/>
                <a:latin typeface="+mn-lt"/>
                <a:ea typeface="+mn-ea"/>
                <a:cs typeface="+mn-cs"/>
              </a:rPr>
              <a:t>Biospecimens</a:t>
            </a:r>
            <a:endParaRPr lang="en-US" sz="1800" b="1" dirty="0"/>
          </a:p>
          <a:p>
            <a:r>
              <a:rPr lang="en-US" sz="1800" b="1" dirty="0"/>
              <a:t>          </a:t>
            </a:r>
            <a:r>
              <a:rPr lang="en-US" sz="1200" dirty="0">
                <a:solidFill>
                  <a:schemeClr val="dk1"/>
                </a:solidFill>
                <a:effectLst/>
                <a:latin typeface="+mn-lt"/>
                <a:ea typeface="+mn-ea"/>
                <a:cs typeface="+mn-cs"/>
              </a:rPr>
              <a:t>N=1</a:t>
            </a:r>
            <a:endParaRPr lang="en-US" sz="1200" dirty="0">
              <a:effectLst/>
            </a:endParaRPr>
          </a:p>
          <a:p>
            <a:endParaRPr lang="en-US" sz="1100" b="1" dirty="0"/>
          </a:p>
        </p:txBody>
      </p:sp>
      <p:sp>
        <p:nvSpPr>
          <p:cNvPr id="13" name="TextBox 7">
            <a:extLst>
              <a:ext uri="{FF2B5EF4-FFF2-40B4-BE49-F238E27FC236}">
                <a16:creationId xmlns:a16="http://schemas.microsoft.com/office/drawing/2014/main" id="{722690F3-3922-44BE-B689-0CFA63B1898B}"/>
              </a:ext>
            </a:extLst>
          </p:cNvPr>
          <p:cNvSpPr txBox="1"/>
          <p:nvPr/>
        </p:nvSpPr>
        <p:spPr>
          <a:xfrm>
            <a:off x="8174362" y="4338902"/>
            <a:ext cx="1850870" cy="1087721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800" b="1" dirty="0"/>
              <a:t>Clinical data sharing</a:t>
            </a:r>
          </a:p>
          <a:p>
            <a:pPr algn="ctr"/>
            <a:r>
              <a:rPr lang="en-US" sz="1200" dirty="0"/>
              <a:t>N=3</a:t>
            </a:r>
          </a:p>
        </p:txBody>
      </p:sp>
      <p:sp>
        <p:nvSpPr>
          <p:cNvPr id="14" name="TextBox 8">
            <a:extLst>
              <a:ext uri="{FF2B5EF4-FFF2-40B4-BE49-F238E27FC236}">
                <a16:creationId xmlns:a16="http://schemas.microsoft.com/office/drawing/2014/main" id="{35B0656E-6561-4A4B-836E-18DB7B73EF21}"/>
              </a:ext>
            </a:extLst>
          </p:cNvPr>
          <p:cNvSpPr txBox="1"/>
          <p:nvPr/>
        </p:nvSpPr>
        <p:spPr>
          <a:xfrm>
            <a:off x="6490188" y="3227395"/>
            <a:ext cx="687066" cy="335716"/>
          </a:xfrm>
          <a:prstGeom prst="rect">
            <a:avLst/>
          </a:prstGeom>
          <a:noFill/>
          <a:ln w="9525" cmpd="sng">
            <a:solidFill>
              <a:schemeClr val="lt1">
                <a:shade val="50000"/>
              </a:schemeClr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/>
              <a:t>N=4</a:t>
            </a:r>
          </a:p>
        </p:txBody>
      </p:sp>
      <p:sp>
        <p:nvSpPr>
          <p:cNvPr id="15" name="TextBox 9">
            <a:extLst>
              <a:ext uri="{FF2B5EF4-FFF2-40B4-BE49-F238E27FC236}">
                <a16:creationId xmlns:a16="http://schemas.microsoft.com/office/drawing/2014/main" id="{69BC2B2A-A3C4-4568-8DA7-50CE92DAAF12}"/>
              </a:ext>
            </a:extLst>
          </p:cNvPr>
          <p:cNvSpPr txBox="1"/>
          <p:nvPr/>
        </p:nvSpPr>
        <p:spPr>
          <a:xfrm>
            <a:off x="8101901" y="3227395"/>
            <a:ext cx="687066" cy="335716"/>
          </a:xfrm>
          <a:prstGeom prst="rect">
            <a:avLst/>
          </a:prstGeom>
          <a:noFill/>
          <a:ln w="9525" cmpd="sng">
            <a:solidFill>
              <a:schemeClr val="lt1">
                <a:shade val="50000"/>
              </a:schemeClr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/>
              <a:t>N=3</a:t>
            </a:r>
          </a:p>
        </p:txBody>
      </p:sp>
      <p:sp>
        <p:nvSpPr>
          <p:cNvPr id="16" name="TextBox 10">
            <a:extLst>
              <a:ext uri="{FF2B5EF4-FFF2-40B4-BE49-F238E27FC236}">
                <a16:creationId xmlns:a16="http://schemas.microsoft.com/office/drawing/2014/main" id="{8AA1B1A4-F0CB-482F-B224-5DAFC4BE75E5}"/>
              </a:ext>
            </a:extLst>
          </p:cNvPr>
          <p:cNvSpPr txBox="1"/>
          <p:nvPr/>
        </p:nvSpPr>
        <p:spPr>
          <a:xfrm>
            <a:off x="7342954" y="4564716"/>
            <a:ext cx="687066" cy="335716"/>
          </a:xfrm>
          <a:prstGeom prst="rect">
            <a:avLst/>
          </a:prstGeom>
          <a:noFill/>
          <a:ln w="9525" cmpd="sng">
            <a:solidFill>
              <a:schemeClr val="lt1">
                <a:shade val="50000"/>
              </a:schemeClr>
            </a:solidFill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/>
              <a:t>N=2</a:t>
            </a:r>
          </a:p>
        </p:txBody>
      </p:sp>
      <p:sp>
        <p:nvSpPr>
          <p:cNvPr id="17" name="TextBox 11">
            <a:extLst>
              <a:ext uri="{FF2B5EF4-FFF2-40B4-BE49-F238E27FC236}">
                <a16:creationId xmlns:a16="http://schemas.microsoft.com/office/drawing/2014/main" id="{2053C145-0895-49E1-8920-80D84BE18237}"/>
              </a:ext>
            </a:extLst>
          </p:cNvPr>
          <p:cNvSpPr txBox="1"/>
          <p:nvPr/>
        </p:nvSpPr>
        <p:spPr>
          <a:xfrm>
            <a:off x="7262691" y="3707483"/>
            <a:ext cx="771196" cy="33571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/>
              <a:t>N=18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2D5A505-E8B3-48FE-94A8-3C3D2F7273AB}"/>
              </a:ext>
            </a:extLst>
          </p:cNvPr>
          <p:cNvSpPr txBox="1"/>
          <p:nvPr/>
        </p:nvSpPr>
        <p:spPr>
          <a:xfrm>
            <a:off x="133381" y="229949"/>
            <a:ext cx="1166286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Supplemental Digital Content Appendix 2: </a:t>
            </a:r>
          </a:p>
          <a:p>
            <a:r>
              <a:rPr lang="en-US" sz="2000" dirty="0"/>
              <a:t>Hub Broad-Scale Informed Consent Policy Activity Across Domains</a:t>
            </a:r>
          </a:p>
        </p:txBody>
      </p:sp>
    </p:spTree>
    <p:extLst>
      <p:ext uri="{BB962C8B-B14F-4D97-AF65-F5344CB8AC3E}">
        <p14:creationId xmlns:p14="http://schemas.microsoft.com/office/powerpoint/2010/main" val="37484931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54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'Brien, Carey Meredith</dc:creator>
  <cp:lastModifiedBy>Jerome, Rebecca</cp:lastModifiedBy>
  <cp:revision>5</cp:revision>
  <dcterms:created xsi:type="dcterms:W3CDTF">2018-12-11T15:18:25Z</dcterms:created>
  <dcterms:modified xsi:type="dcterms:W3CDTF">2019-06-26T17:33:05Z</dcterms:modified>
</cp:coreProperties>
</file>